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  <p:sldId id="260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041"/>
    <p:restoredTop sz="95964"/>
  </p:normalViewPr>
  <p:slideViewPr>
    <p:cSldViewPr snapToGrid="0" snapToObjects="1">
      <p:cViewPr>
        <p:scale>
          <a:sx n="127" d="100"/>
          <a:sy n="127" d="100"/>
        </p:scale>
        <p:origin x="126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497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381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5054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521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0476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193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255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61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9323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648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1771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C07F4-D48E-7547-BF05-991EDAB4ADA7}" type="datetimeFigureOut">
              <a:rPr kumimoji="1" lang="ja-JP" altLang="en-US" smtClean="0"/>
              <a:t>2021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C2F87D-6114-F842-B915-20DE74F23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2875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nishios@affrc.go.jp" TargetMode="Externa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hyperlink" Target="mailto:nishios@affrc.go.jp" TargetMode="Externa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mailto:nishios@affrc.go.jp" TargetMode="External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7976DAE-9ECA-0F40-B31F-E1591FB57E40}"/>
              </a:ext>
            </a:extLst>
          </p:cNvPr>
          <p:cNvSpPr txBox="1"/>
          <p:nvPr/>
        </p:nvSpPr>
        <p:spPr>
          <a:xfrm>
            <a:off x="1238743" y="3904690"/>
            <a:ext cx="71330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Figure S1 Plots of average linkage disequilibrium values (</a:t>
            </a:r>
            <a:r>
              <a:rPr lang="en-US" altLang="ja-JP" sz="1200" b="1" i="1" dirty="0">
                <a:latin typeface="Helvetica" pitchFamily="2" charset="0"/>
              </a:rPr>
              <a:t>r</a:t>
            </a:r>
            <a:r>
              <a:rPr lang="en-US" altLang="ja-JP" sz="1200" b="1" baseline="30000" dirty="0">
                <a:latin typeface="Helvetica" pitchFamily="2" charset="0"/>
              </a:rPr>
              <a:t>2</a:t>
            </a:r>
            <a:r>
              <a:rPr lang="en-US" altLang="ja-JP" sz="1200" b="1" dirty="0">
                <a:latin typeface="Helvetica" pitchFamily="2" charset="0"/>
              </a:rPr>
              <a:t>) against physical distances in increments of 10 kb. </a:t>
            </a:r>
            <a:r>
              <a:rPr lang="en-US" altLang="ja-JP" sz="1200" dirty="0">
                <a:latin typeface="Helvetica" pitchFamily="2" charset="0"/>
              </a:rPr>
              <a:t>Gray curves show local polynomial fits obtained using kernel smoothing regression. Dotted lines indicate the genetic distance at which </a:t>
            </a:r>
            <a:r>
              <a:rPr lang="en-US" altLang="ja-JP" sz="1200" i="1" dirty="0">
                <a:latin typeface="Helvetica" pitchFamily="2" charset="0"/>
              </a:rPr>
              <a:t>r</a:t>
            </a:r>
            <a:r>
              <a:rPr lang="en-US" altLang="ja-JP" sz="1200" baseline="30000" dirty="0">
                <a:latin typeface="Helvetica" pitchFamily="2" charset="0"/>
              </a:rPr>
              <a:t>2</a:t>
            </a:r>
            <a:r>
              <a:rPr lang="en-US" altLang="ja-JP" sz="1200" dirty="0">
                <a:latin typeface="Helvetica" pitchFamily="2" charset="0"/>
              </a:rPr>
              <a:t> fell below 0.2</a:t>
            </a:r>
            <a:endParaRPr lang="ja-JP" altLang="ja-JP" sz="1200">
              <a:latin typeface="Helvetica" pitchFamily="2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04ACF6A6-0F4A-0D46-A180-23F5A08CB5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8767" y="133232"/>
            <a:ext cx="6036068" cy="378278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7E706A5-4C09-D44B-82A8-715A386DB11B}"/>
              </a:ext>
            </a:extLst>
          </p:cNvPr>
          <p:cNvSpPr txBox="1"/>
          <p:nvPr/>
        </p:nvSpPr>
        <p:spPr>
          <a:xfrm>
            <a:off x="-1112704" y="404319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EE632E2-3E26-3C44-BC28-4788DA9EDF2F}"/>
              </a:ext>
            </a:extLst>
          </p:cNvPr>
          <p:cNvSpPr txBox="1"/>
          <p:nvPr/>
        </p:nvSpPr>
        <p:spPr>
          <a:xfrm>
            <a:off x="398485" y="5211705"/>
            <a:ext cx="834702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itle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ome-wide association study of individual sugar content and sugar conversion in fruit of Japanese pear (Pyrus spp.)</a:t>
            </a:r>
          </a:p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Nishio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, Takeshi Hayash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2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Kenta Shirasawa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oshihiro Saito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ngo Terakami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orio Takada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Yukie Takeuchi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geki Moriya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amp; Akihiko Itai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</a:t>
            </a:r>
          </a:p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’ addresses: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2-1 Fujimoto, Tsukuba, Ibaraki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esearch Center for Agricultural Information Technology, NARO 3-1-1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nnondai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sukuba, Ibaraki 305-8666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zusa DNA Research Institute, 2-6-7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zusa-Kamatari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Kisarazu, Chiba 292-0818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Morioka, Iwate 020-0123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raduate School of Life and Environmental Sciences, Kyoto Prefectural University, 74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itainayazuma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eika, Kyoto 619-0244, Japan</a:t>
            </a:r>
          </a:p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Corresponding author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ishio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nstitute of Fruit Tree and Tea Science, NARO, 2-1 Fujimoto, Tsukuba, Ibaraki 305-8605, Japan; Tel: +81-88-656-9310 </a:t>
            </a:r>
            <a:r>
              <a:rPr lang="en-US" altLang="ja-JP" sz="800" b="1" kern="100" dirty="0">
                <a:solidFill>
                  <a:srgbClr val="006699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  <a:hlinkClick r:id="rId3"/>
              </a:rPr>
              <a:t>nishios@affrc.go.jp</a:t>
            </a:r>
            <a:endParaRPr lang="en-US" altLang="ja-JP" sz="800" b="1" kern="100" dirty="0">
              <a:solidFill>
                <a:srgbClr val="006699"/>
              </a:solidFill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0662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65BEE60-155E-4B45-B2EF-A12957D00980}"/>
              </a:ext>
            </a:extLst>
          </p:cNvPr>
          <p:cNvSpPr txBox="1"/>
          <p:nvPr/>
        </p:nvSpPr>
        <p:spPr>
          <a:xfrm>
            <a:off x="2543095" y="42829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MLM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3F6D651-5C83-FB4C-B77E-7295042D1F75}"/>
              </a:ext>
            </a:extLst>
          </p:cNvPr>
          <p:cNvSpPr txBox="1"/>
          <p:nvPr/>
        </p:nvSpPr>
        <p:spPr>
          <a:xfrm>
            <a:off x="5989876" y="24907"/>
            <a:ext cx="8931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Helvetica" pitchFamily="2" charset="0"/>
              </a:rPr>
              <a:t>vBayesB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E36E99A-FE67-3640-9783-8186EFD07A06}"/>
              </a:ext>
            </a:extLst>
          </p:cNvPr>
          <p:cNvSpPr txBox="1"/>
          <p:nvPr/>
        </p:nvSpPr>
        <p:spPr>
          <a:xfrm>
            <a:off x="216451" y="4877849"/>
            <a:ext cx="907442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Figure S2 Summary of the </a:t>
            </a:r>
            <a:r>
              <a:rPr lang="en-US" altLang="ja-JP" sz="1200" b="1" dirty="0" err="1">
                <a:latin typeface="Helvetica" pitchFamily="2" charset="0"/>
              </a:rPr>
              <a:t>resultS</a:t>
            </a:r>
            <a:r>
              <a:rPr lang="en-US" altLang="ja-JP" sz="1200" b="1" dirty="0">
                <a:latin typeface="Helvetica" pitchFamily="2" charset="0"/>
              </a:rPr>
              <a:t> of genome-wide association studies using two different models. a</a:t>
            </a:r>
            <a:r>
              <a:rPr lang="en-US" altLang="ja-JP" sz="1200" dirty="0">
                <a:latin typeface="Helvetica" pitchFamily="2" charset="0"/>
              </a:rPr>
              <a:t> Manhattan plots of −log10(p) values based on a MLM for 10 fruit traits. Red lines indicate a false discovery rate of 0.05. Chromosome location information is based on GDDH13 Version 1.1. The fictive chromosome 0 contains all unassigned scaffolds. </a:t>
            </a:r>
            <a:r>
              <a:rPr lang="en-US" altLang="ja-JP" sz="1200" b="1" dirty="0">
                <a:latin typeface="Helvetica" pitchFamily="2" charset="0"/>
              </a:rPr>
              <a:t>b</a:t>
            </a:r>
            <a:r>
              <a:rPr lang="en-US" altLang="ja-JP" sz="1200" dirty="0">
                <a:latin typeface="Helvetica" pitchFamily="2" charset="0"/>
              </a:rPr>
              <a:t> Posterior probability of having a QTL based on </a:t>
            </a:r>
            <a:r>
              <a:rPr lang="en-US" altLang="ja-JP" sz="1200" dirty="0" err="1">
                <a:latin typeface="Helvetica" pitchFamily="2" charset="0"/>
              </a:rPr>
              <a:t>vBayesB</a:t>
            </a:r>
            <a:r>
              <a:rPr lang="en-US" altLang="ja-JP" sz="1200" dirty="0">
                <a:latin typeface="Helvetica" pitchFamily="2" charset="0"/>
              </a:rPr>
              <a:t>, estimated for 10 fruit traits</a:t>
            </a:r>
            <a:endParaRPr lang="ja-JP" altLang="ja-JP" sz="1200">
              <a:latin typeface="Helvetica" pitchFamily="2" charset="0"/>
            </a:endParaRPr>
          </a:p>
          <a:p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8268E6B-E1F0-464B-8869-0B01FCC0E718}"/>
              </a:ext>
            </a:extLst>
          </p:cNvPr>
          <p:cNvSpPr txBox="1"/>
          <p:nvPr/>
        </p:nvSpPr>
        <p:spPr>
          <a:xfrm>
            <a:off x="1477813" y="39169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(a)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2252426-0D8C-0343-9A91-15F323FC9F23}"/>
              </a:ext>
            </a:extLst>
          </p:cNvPr>
          <p:cNvSpPr txBox="1"/>
          <p:nvPr/>
        </p:nvSpPr>
        <p:spPr>
          <a:xfrm>
            <a:off x="4753664" y="17948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(b)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6EE3E51-6708-A040-933F-D286A56D2115}"/>
              </a:ext>
            </a:extLst>
          </p:cNvPr>
          <p:cNvSpPr txBox="1"/>
          <p:nvPr/>
        </p:nvSpPr>
        <p:spPr>
          <a:xfrm>
            <a:off x="216451" y="5647819"/>
            <a:ext cx="834702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itle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ome-wide association study of individual sugar content and sugar conversion in fruit of Japanese pear (Pyrus spp.)</a:t>
            </a:r>
          </a:p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Nishio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, Takeshi Hayash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2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Kenta Shirasawa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oshihiro Saito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ngo Terakami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orio Takada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Yukie Takeuchi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geki Moriya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amp; Akihiko Itai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</a:t>
            </a:r>
          </a:p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’ addresses: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2-1 Fujimoto, Tsukuba, Ibaraki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esearch Center for Agricultural Information Technology, NARO 3-1-1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nnondai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sukuba, Ibaraki 305-8666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zusa DNA Research Institute, 2-6-7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zusa-Kamatari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Kisarazu, Chiba 292-0818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Morioka, Iwate 020-0123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raduate School of Life and Environmental Sciences, Kyoto Prefectural University, 74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itainayazuma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eika, Kyoto 619-0244, Japan</a:t>
            </a:r>
          </a:p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Corresponding author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ishio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nstitute of Fruit Tree and Tea Science, NARO, 2-1 Fujimoto, Tsukuba, Ibaraki 305-8605, Japan; Tel: +81-88-656-9310 </a:t>
            </a:r>
            <a:r>
              <a:rPr lang="en-US" altLang="ja-JP" sz="800" b="1" kern="100" dirty="0">
                <a:solidFill>
                  <a:srgbClr val="006699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  <a:hlinkClick r:id="rId2"/>
              </a:rPr>
              <a:t>nishios@affrc.go.jp</a:t>
            </a:r>
            <a:endParaRPr lang="en-US" altLang="ja-JP" sz="800" b="1" kern="100" dirty="0">
              <a:solidFill>
                <a:srgbClr val="006699"/>
              </a:solidFill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6509F70D-C892-7E4A-BA59-0CB198EE4B8C}"/>
              </a:ext>
            </a:extLst>
          </p:cNvPr>
          <p:cNvGrpSpPr/>
          <p:nvPr/>
        </p:nvGrpSpPr>
        <p:grpSpPr>
          <a:xfrm>
            <a:off x="1402229" y="483645"/>
            <a:ext cx="6409496" cy="4176924"/>
            <a:chOff x="1402229" y="483645"/>
            <a:chExt cx="6409496" cy="4176924"/>
          </a:xfrm>
        </p:grpSpPr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6A038621-BE16-5F4C-A33C-D08FFE4263B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02229" y="483645"/>
              <a:ext cx="2793345" cy="4176543"/>
            </a:xfrm>
            <a:prstGeom prst="rect">
              <a:avLst/>
            </a:prstGeom>
          </p:spPr>
        </p:pic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E5F3DCC3-E2B7-314A-A5E9-A0C608291A41}"/>
                </a:ext>
              </a:extLst>
            </p:cNvPr>
            <p:cNvCxnSpPr>
              <a:cxnSpLocks/>
            </p:cNvCxnSpPr>
            <p:nvPr/>
          </p:nvCxnSpPr>
          <p:spPr>
            <a:xfrm>
              <a:off x="1585798" y="944823"/>
              <a:ext cx="1096233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01A1E71E-8605-E147-98DE-F576F6F1DE2D}"/>
                </a:ext>
              </a:extLst>
            </p:cNvPr>
            <p:cNvCxnSpPr>
              <a:cxnSpLocks/>
            </p:cNvCxnSpPr>
            <p:nvPr/>
          </p:nvCxnSpPr>
          <p:spPr>
            <a:xfrm>
              <a:off x="2980671" y="872202"/>
              <a:ext cx="1096233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DC2CE466-4A5A-584F-90D7-E4A8DCBFEC69}"/>
                </a:ext>
              </a:extLst>
            </p:cNvPr>
            <p:cNvCxnSpPr>
              <a:cxnSpLocks/>
            </p:cNvCxnSpPr>
            <p:nvPr/>
          </p:nvCxnSpPr>
          <p:spPr>
            <a:xfrm>
              <a:off x="1585798" y="1856568"/>
              <a:ext cx="1096233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AF7329F3-3620-AB40-9C5B-C0EB4BF44710}"/>
                </a:ext>
              </a:extLst>
            </p:cNvPr>
            <p:cNvCxnSpPr>
              <a:cxnSpLocks/>
            </p:cNvCxnSpPr>
            <p:nvPr/>
          </p:nvCxnSpPr>
          <p:spPr>
            <a:xfrm>
              <a:off x="2980672" y="4363617"/>
              <a:ext cx="1096233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8E38EAD3-9A79-6044-8531-2BB8CC39BEEE}"/>
                </a:ext>
              </a:extLst>
            </p:cNvPr>
            <p:cNvCxnSpPr>
              <a:cxnSpLocks/>
            </p:cNvCxnSpPr>
            <p:nvPr/>
          </p:nvCxnSpPr>
          <p:spPr>
            <a:xfrm>
              <a:off x="2980671" y="2656541"/>
              <a:ext cx="1096233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28" name="円/楕円 27">
              <a:extLst>
                <a:ext uri="{FF2B5EF4-FFF2-40B4-BE49-F238E27FC236}">
                  <a16:creationId xmlns:a16="http://schemas.microsoft.com/office/drawing/2014/main" id="{05FF9407-EFE5-5346-916E-B420DDAC3EA1}"/>
                </a:ext>
              </a:extLst>
            </p:cNvPr>
            <p:cNvSpPr/>
            <p:nvPr/>
          </p:nvSpPr>
          <p:spPr>
            <a:xfrm flipV="1">
              <a:off x="2557779" y="545801"/>
              <a:ext cx="147410" cy="16843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円/楕円 28">
              <a:extLst>
                <a:ext uri="{FF2B5EF4-FFF2-40B4-BE49-F238E27FC236}">
                  <a16:creationId xmlns:a16="http://schemas.microsoft.com/office/drawing/2014/main" id="{A1C1036E-1E75-4B41-AD76-0AC1610B8908}"/>
                </a:ext>
              </a:extLst>
            </p:cNvPr>
            <p:cNvSpPr/>
            <p:nvPr/>
          </p:nvSpPr>
          <p:spPr>
            <a:xfrm flipV="1">
              <a:off x="2543095" y="1470065"/>
              <a:ext cx="147410" cy="16843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円/楕円 29">
              <a:extLst>
                <a:ext uri="{FF2B5EF4-FFF2-40B4-BE49-F238E27FC236}">
                  <a16:creationId xmlns:a16="http://schemas.microsoft.com/office/drawing/2014/main" id="{A2258397-4D35-A64A-9A17-A614F314E50F}"/>
                </a:ext>
              </a:extLst>
            </p:cNvPr>
            <p:cNvSpPr/>
            <p:nvPr/>
          </p:nvSpPr>
          <p:spPr>
            <a:xfrm flipV="1">
              <a:off x="3978781" y="1418847"/>
              <a:ext cx="147410" cy="16843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" name="円/楕円 30">
              <a:extLst>
                <a:ext uri="{FF2B5EF4-FFF2-40B4-BE49-F238E27FC236}">
                  <a16:creationId xmlns:a16="http://schemas.microsoft.com/office/drawing/2014/main" id="{5B39665A-CD0E-7843-847D-A0EF9607A256}"/>
                </a:ext>
              </a:extLst>
            </p:cNvPr>
            <p:cNvSpPr/>
            <p:nvPr/>
          </p:nvSpPr>
          <p:spPr>
            <a:xfrm flipV="1">
              <a:off x="4077411" y="2335542"/>
              <a:ext cx="147410" cy="16843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円/楕円 31">
              <a:extLst>
                <a:ext uri="{FF2B5EF4-FFF2-40B4-BE49-F238E27FC236}">
                  <a16:creationId xmlns:a16="http://schemas.microsoft.com/office/drawing/2014/main" id="{29CB7B80-15F9-544C-8349-2A5A701E8939}"/>
                </a:ext>
              </a:extLst>
            </p:cNvPr>
            <p:cNvSpPr/>
            <p:nvPr/>
          </p:nvSpPr>
          <p:spPr>
            <a:xfrm flipV="1">
              <a:off x="3978781" y="3927094"/>
              <a:ext cx="147410" cy="16843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33" name="図 32">
              <a:extLst>
                <a:ext uri="{FF2B5EF4-FFF2-40B4-BE49-F238E27FC236}">
                  <a16:creationId xmlns:a16="http://schemas.microsoft.com/office/drawing/2014/main" id="{3DC34E15-5101-494A-85F2-74DE343EA9B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27363" y="484026"/>
              <a:ext cx="2784362" cy="417654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504323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7A19CE2-AC5A-7A4D-A264-2A91720827F2}"/>
              </a:ext>
            </a:extLst>
          </p:cNvPr>
          <p:cNvSpPr txBox="1"/>
          <p:nvPr/>
        </p:nvSpPr>
        <p:spPr>
          <a:xfrm>
            <a:off x="0" y="4587088"/>
            <a:ext cx="9284647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Figure S3 Heatmap showing the percentage of the phenotypic variance explained by each QTL in each population. </a:t>
            </a:r>
            <a:r>
              <a:rPr lang="en-US" altLang="ja-JP" sz="1200" dirty="0">
                <a:latin typeface="Helvetica" pitchFamily="2" charset="0"/>
              </a:rPr>
              <a:t>The percentages for the cultivar collection (designated as “Cultivar”) and for all 1218 accessions including the populations and cultivars (designated as “ALL”) are shown on the right. The prefix </a:t>
            </a:r>
            <a:r>
              <a:rPr lang="en-US" altLang="ja-JP" sz="1200" dirty="0" err="1">
                <a:latin typeface="Helvetica" pitchFamily="2" charset="0"/>
              </a:rPr>
              <a:t>rrBLUP</a:t>
            </a:r>
            <a:r>
              <a:rPr lang="en-US" altLang="ja-JP" sz="1200" dirty="0">
                <a:latin typeface="Helvetica" pitchFamily="2" charset="0"/>
              </a:rPr>
              <a:t> indicates the SNPs identified in the MLM-based GWAS analysis; </a:t>
            </a:r>
            <a:r>
              <a:rPr lang="en-US" altLang="ja-JP" sz="1200" dirty="0" err="1">
                <a:latin typeface="Helvetica" pitchFamily="2" charset="0"/>
              </a:rPr>
              <a:t>BayesB</a:t>
            </a:r>
            <a:r>
              <a:rPr lang="en-US" altLang="ja-JP" sz="1200" dirty="0">
                <a:latin typeface="Helvetica" pitchFamily="2" charset="0"/>
              </a:rPr>
              <a:t> indicates those identified in the </a:t>
            </a:r>
            <a:r>
              <a:rPr lang="en-US" altLang="ja-JP" sz="1200" dirty="0" err="1">
                <a:latin typeface="Helvetica" pitchFamily="2" charset="0"/>
              </a:rPr>
              <a:t>vBayesB</a:t>
            </a:r>
            <a:r>
              <a:rPr lang="en-US" altLang="ja-JP" sz="1200" dirty="0">
                <a:latin typeface="Helvetica" pitchFamily="2" charset="0"/>
              </a:rPr>
              <a:t>-based GWAS. A blank indicates that the population showed no segregation for the SNPs. The intensity of the red color corresponds to the percentage of phenotypic variance explained</a:t>
            </a:r>
            <a:endParaRPr lang="ja-JP" altLang="ja-JP" sz="1200">
              <a:latin typeface="Helvetica" pitchFamily="2" charset="0"/>
            </a:endParaRPr>
          </a:p>
        </p:txBody>
      </p:sp>
      <p:pic>
        <p:nvPicPr>
          <p:cNvPr id="4" name="図 3" descr="テキスト, 手紙&#10;&#10;自動的に生成された説明">
            <a:extLst>
              <a:ext uri="{FF2B5EF4-FFF2-40B4-BE49-F238E27FC236}">
                <a16:creationId xmlns:a16="http://schemas.microsoft.com/office/drawing/2014/main" id="{6AA27606-EC58-CD41-BEB1-ACEC6F72B3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0748" y="103416"/>
            <a:ext cx="6152322" cy="456353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04644DA-5189-8E4F-85D4-54D0EABA31B3}"/>
              </a:ext>
            </a:extLst>
          </p:cNvPr>
          <p:cNvSpPr txBox="1"/>
          <p:nvPr/>
        </p:nvSpPr>
        <p:spPr>
          <a:xfrm>
            <a:off x="0" y="5602751"/>
            <a:ext cx="840313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itle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ome-wide association study of individual sugar content and sugar conversion in fruit of Japanese pear (Pyrus spp.)</a:t>
            </a:r>
          </a:p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Nishio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, Takeshi Hayash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2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Kenta Shirasawa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oshihiro Saito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ngo Terakami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orio Takada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Yukie Takeuchi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geki Moriya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amp; Akihiko Itai</a:t>
            </a: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</a:t>
            </a:r>
          </a:p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’ addresses: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2-1 Fujimoto, Tsukuba, Ibaraki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esearch Center for Agricultural Information Technology, NARO 3-1-1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nnondai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sukuba, Ibaraki 305-8666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zusa DNA Research Institute, 2-6-7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zusa-Kamatari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Kisarazu, Chiba 292-0818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</a:t>
            </a:r>
            <a:r>
              <a:rPr lang="en-US" altLang="ja-JP" sz="800" kern="10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ree and Tea Science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ARO, Morioka, Iwate 020-0123, Japan</a:t>
            </a:r>
          </a:p>
          <a:p>
            <a:pPr>
              <a:spcAft>
                <a:spcPts val="0"/>
              </a:spcAft>
            </a:pPr>
            <a:r>
              <a:rPr lang="en-US" altLang="ja-JP" sz="800" kern="100" baseline="300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raduate School of Life and Environmental Sciences, Kyoto Prefectural University, 74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itainayazuma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eika, Kyoto 619-0244, Japan</a:t>
            </a:r>
          </a:p>
          <a:p>
            <a:pPr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Corresponding author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ishio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nstitute of Fruit Tree and Tea Science, NARO, 2-1 Fujimoto, Tsukuba, Ibaraki 305-8605, Japan; Tel: +81-88-656-9310 </a:t>
            </a:r>
            <a:r>
              <a:rPr lang="en-US" altLang="ja-JP" sz="800" b="1" kern="100" dirty="0">
                <a:solidFill>
                  <a:srgbClr val="006699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  <a:hlinkClick r:id="rId3"/>
              </a:rPr>
              <a:t>nishios@affrc.go.jp</a:t>
            </a:r>
            <a:endParaRPr lang="en-US" altLang="ja-JP" sz="800" b="1" kern="100" dirty="0">
              <a:solidFill>
                <a:srgbClr val="006699"/>
              </a:solidFill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2287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76</TotalTime>
  <Words>763</Words>
  <Application>Microsoft Macintosh PowerPoint</Application>
  <PresentationFormat>画面に合わせる (4:3)</PresentationFormat>
  <Paragraphs>3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尾　聡悟</dc:creator>
  <cp:lastModifiedBy>西尾　聡悟</cp:lastModifiedBy>
  <cp:revision>103</cp:revision>
  <dcterms:created xsi:type="dcterms:W3CDTF">2020-08-08T01:56:28Z</dcterms:created>
  <dcterms:modified xsi:type="dcterms:W3CDTF">2021-05-18T14:07:21Z</dcterms:modified>
</cp:coreProperties>
</file>